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5" d="100"/>
          <a:sy n="105" d="100"/>
        </p:scale>
        <p:origin x="-96" y="-17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1C788D49-D8A8-46AD-8655-3AC3767B94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xmlns="" id="{F20B279F-6641-48D8-90F6-DCBFE5B29B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EAC49850-DE88-4BA7-96F4-C9288995F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E6577A1F-5788-4ABE-ABB8-F09FA3381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D725F618-1725-4744-B2FA-93DFCE7D0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008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2DD5660F-ED8E-45D2-A408-15EA1CC4F4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64CA81F3-7F5E-4A73-9144-896DB0A29A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BFC45517-4269-44AE-A81C-ADA5B10F4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F0D4919F-6378-4612-A296-9037120ACA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98A322C9-A111-4633-BD32-B86900A39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322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xmlns="" id="{B23681A5-0DA6-45C5-AB7B-3CB27399D7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50C5579D-3F33-46C0-9C2B-77F6E918D1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4D0FA09E-65DE-412B-A4E8-3C5F39E10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E801FD9A-0B38-4FEA-B072-5F3A1F382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C4C42644-3479-4E1A-AEB4-CA6C67590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656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AC12068A-291F-4CF5-B0E7-369B5D9C05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29C668CD-7222-4118-AB4E-077378FBF8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D532B638-1706-418D-9138-80AC3D895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D72D9CF2-01FC-404F-8FDB-FFEA4DF96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81A7B17F-A086-4080-82D2-65AE23282E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121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6F443E5F-163A-4AC7-B0D4-6A15E3ACBD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0EF8AAD9-864A-4DC0-BEB5-B30968759E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D177A7F1-64CA-4039-B967-5A75A4B5D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2131F8C1-FDEF-4A70-97D7-A0DE48E213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9F62703F-9CD2-482B-9711-9C21D3DCD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065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39AFA86E-5E4C-4CAF-8E22-F1997606A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4473D109-1525-4D46-95D1-66E8076111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66919E49-D287-4BDE-B2F4-BFFB57A9CE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D7A02B4B-197B-4DF1-8AC7-6E3D075DD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2E17B4BD-3B88-4476-8938-0DF1B7E091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0AFEB73E-953A-43D4-87F3-CC099CB338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2245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6FBE979A-1DB2-4431-94D5-8D5C7E9797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E5565FDC-80CA-48AC-B3F5-1722026FBE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3143CFA7-27F7-4D43-81CD-39B765EDE2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xmlns="" id="{615A2590-9BF3-4B26-A1EA-83EC96FCF4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xmlns="" id="{D8987CD6-AF11-49D3-AB08-CFD78D2436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xmlns="" id="{4844F401-3D87-41CF-80A6-29BF60FA0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xmlns="" id="{D8E06828-0670-405D-86CD-DFCF16250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xmlns="" id="{2663E281-CA14-43B8-B8A2-11FFBA7DE0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308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4427EC21-9F91-41C4-9BF4-F81A85EF73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xmlns="" id="{795221FD-B3B1-458E-9228-F6D50BF7F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xmlns="" id="{448C1B74-8872-469C-8B83-FE98FA383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xmlns="" id="{1320F248-E822-4A9D-AD75-CE11F3665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178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xmlns="" id="{09CFC28E-E097-483E-A452-B9583082B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xmlns="" id="{D491F5E3-87FF-440B-9CA3-FF74A9C31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xmlns="" id="{1D5F72CB-07FB-4D92-8DCF-F6B09DB80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287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B990E1E5-7594-4C28-8ABF-46F94FE504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F7824906-3D31-40C7-A012-635F1E924E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06EC7E7F-E652-4988-A3A1-F5220276A0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35C8E84C-F1E7-4EEC-A2CE-AB7A6BF74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148A0844-2B4C-4F1B-A8A9-AB95E5911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39F15216-A864-41B2-AB64-ED6037DC1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611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CE758523-8D92-439E-9771-CF0DFDB811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xmlns="" id="{2969F480-37FE-44EC-B31D-50B5B10EEA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01B01BC0-D6D3-4025-AB42-9DC334E2FE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87BA117C-E3D6-44C7-8816-E62EF3EC66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44A2654F-7AF1-4E07-A363-641AA54DB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006BFF30-F6EC-4CA6-BFC8-894108111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477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xmlns="" id="{9B4F656C-D3BB-4AD8-B9A3-1EA7D28B7F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4401EAEE-8ECC-4556-A20E-DADB2D365B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659603DA-25CC-498C-9D29-BCACB5847B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5568A-3C93-4D7C-A3ED-B70AF4BD02EC}" type="datetimeFigureOut">
              <a:rPr lang="en-US" smtClean="0"/>
              <a:t>2/11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7E452EEA-3577-41C6-8817-4249353A2C3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512F1E92-4AA7-4EE8-8A5A-2DF3CF47F9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7142E-EFC5-41DE-82F2-60CAA1BCE7C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418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D17797BB-1452-499D-9E53-23BC235C0CD3}"/>
              </a:ext>
            </a:extLst>
          </p:cNvPr>
          <p:cNvSpPr/>
          <p:nvPr/>
        </p:nvSpPr>
        <p:spPr>
          <a:xfrm>
            <a:off x="-15240" y="1213677"/>
            <a:ext cx="1389380" cy="459356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720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deb2414_s0002g000453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88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2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7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06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4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4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32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33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IRChr04g015415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SC8Chr04g013840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QP8Chr04g01309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300Chr04g01182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61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8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6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5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1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6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8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3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38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3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39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06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6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600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36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31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39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7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5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5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6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1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7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9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deb2414_s0002g0004534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m_Chr07g00585851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m_Chr07g00585861-RLCK</a:t>
            </a:r>
          </a:p>
        </p:txBody>
      </p:sp>
      <p:sp>
        <p:nvSpPr>
          <p:cNvPr id="6" name="CuadroTexto 4">
            <a:extLst>
              <a:ext uri="{FF2B5EF4-FFF2-40B4-BE49-F238E27FC236}">
                <a16:creationId xmlns:a16="http://schemas.microsoft.com/office/drawing/2014/main" xmlns="" id="{9496D158-A620-4852-B4C5-9AE2B2C6A21C}"/>
              </a:ext>
            </a:extLst>
          </p:cNvPr>
          <p:cNvSpPr txBox="1">
            <a:spLocks/>
          </p:cNvSpPr>
          <p:nvPr/>
        </p:nvSpPr>
        <p:spPr>
          <a:xfrm>
            <a:off x="971032" y="270597"/>
            <a:ext cx="10354854" cy="738664"/>
          </a:xfrm>
          <a:prstGeom prst="rect">
            <a:avLst/>
          </a:prstGeom>
          <a:noFill/>
        </p:spPr>
        <p:txBody>
          <a:bodyPr vert="horz" wrap="square" lIns="91440" tIns="45720" rIns="91440" bIns="45720" rtlCol="0" anchor="b">
            <a:sp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US" sz="1400" b="1" dirty="0" err="1">
                <a:latin typeface="+mn-lt"/>
              </a:rPr>
              <a:t>Fernández-Melero</a:t>
            </a:r>
            <a:r>
              <a:rPr lang="en-US" sz="1400" b="1" dirty="0">
                <a:latin typeface="+mn-lt"/>
              </a:rPr>
              <a:t> et al</a:t>
            </a:r>
            <a:r>
              <a:rPr lang="en-US" sz="1400" b="1" dirty="0" smtClean="0">
                <a:latin typeface="+mn-lt"/>
              </a:rPr>
              <a:t>. Figure S9.</a:t>
            </a:r>
            <a:r>
              <a:rPr lang="en-US" sz="1400" dirty="0" smtClean="0">
                <a:latin typeface="+mn-lt"/>
              </a:rPr>
              <a:t> </a:t>
            </a:r>
            <a:r>
              <a:rPr lang="en-US" sz="1400" dirty="0">
                <a:latin typeface="+mn-lt"/>
              </a:rPr>
              <a:t>Amino acid alignment of the full length HannDeb2Chr04g005720 and the truncated kinases HannDeb2Chr04g005600 + HannDeb2Chr04g005610 and its orthologs from different sequenced sunflower genome assemblies. Unique variations in HannDeb2Chr04g005720 are indicated with red arrows. </a:t>
            </a:r>
            <a:endParaRPr lang="es-ES" sz="1400" dirty="0">
              <a:solidFill>
                <a:srgbClr val="FF0000"/>
              </a:solidFill>
              <a:latin typeface="+mn-lt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0A02AD49-145C-4091-AE36-347C18F1AC2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74" t="4968" b="9234"/>
          <a:stretch/>
        </p:blipFill>
        <p:spPr>
          <a:xfrm>
            <a:off x="1276968" y="1241570"/>
            <a:ext cx="10915032" cy="4471333"/>
          </a:xfrm>
          <a:prstGeom prst="rect">
            <a:avLst/>
          </a:prstGeom>
        </p:spPr>
      </p:pic>
      <p:sp>
        <p:nvSpPr>
          <p:cNvPr id="7" name="Rectángulo 6">
            <a:extLst>
              <a:ext uri="{FF2B5EF4-FFF2-40B4-BE49-F238E27FC236}">
                <a16:creationId xmlns:a16="http://schemas.microsoft.com/office/drawing/2014/main" xmlns="" id="{A4D43125-E4E3-4FB5-9FA3-475146497C0C}"/>
              </a:ext>
            </a:extLst>
          </p:cNvPr>
          <p:cNvSpPr/>
          <p:nvPr/>
        </p:nvSpPr>
        <p:spPr>
          <a:xfrm>
            <a:off x="76200" y="1245658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xmlns="" id="{7BB64B1D-CFB3-49CF-A34D-2AB7866FAD36}"/>
              </a:ext>
            </a:extLst>
          </p:cNvPr>
          <p:cNvSpPr/>
          <p:nvPr/>
        </p:nvSpPr>
        <p:spPr>
          <a:xfrm>
            <a:off x="76200" y="2935400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xmlns="" id="{F613C89F-6086-4538-A285-2F250D0E2919}"/>
              </a:ext>
            </a:extLst>
          </p:cNvPr>
          <p:cNvSpPr/>
          <p:nvPr/>
        </p:nvSpPr>
        <p:spPr>
          <a:xfrm>
            <a:off x="80954" y="4328034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3553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9D6B6067-25BC-470E-94B6-CA2B2FD5BB2D}"/>
              </a:ext>
            </a:extLst>
          </p:cNvPr>
          <p:cNvSpPr/>
          <p:nvPr/>
        </p:nvSpPr>
        <p:spPr>
          <a:xfrm>
            <a:off x="3810" y="1041729"/>
            <a:ext cx="1389380" cy="459356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720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deb2414_s0002g000453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88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2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7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06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4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4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32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33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IRChr04g015415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SC8Chr04g013840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QP8Chr04g01309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300Chr04g01182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61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8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6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5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1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6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8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3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38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3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39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06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6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600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36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31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39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7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5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5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6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1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7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9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deb2414_s0002g0004534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m_Chr07g00585851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m_Chr07g00585861-RLCK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07C928D3-CAE3-402F-A640-7438D1A46D1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02" t="5099" b="8572"/>
          <a:stretch/>
        </p:blipFill>
        <p:spPr>
          <a:xfrm>
            <a:off x="1316990" y="1089025"/>
            <a:ext cx="10875010" cy="4498975"/>
          </a:xfrm>
          <a:prstGeom prst="rect">
            <a:avLst/>
          </a:prstGeom>
        </p:spPr>
      </p:pic>
      <p:sp>
        <p:nvSpPr>
          <p:cNvPr id="5" name="Flecha: hacia abajo 4">
            <a:extLst>
              <a:ext uri="{FF2B5EF4-FFF2-40B4-BE49-F238E27FC236}">
                <a16:creationId xmlns:a16="http://schemas.microsoft.com/office/drawing/2014/main" xmlns="" id="{86B09730-4465-4B10-860E-E8039BBAC6FD}"/>
              </a:ext>
            </a:extLst>
          </p:cNvPr>
          <p:cNvSpPr/>
          <p:nvPr/>
        </p:nvSpPr>
        <p:spPr>
          <a:xfrm>
            <a:off x="6594440" y="837422"/>
            <a:ext cx="252000" cy="216000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ángulo 6">
            <a:extLst>
              <a:ext uri="{FF2B5EF4-FFF2-40B4-BE49-F238E27FC236}">
                <a16:creationId xmlns:a16="http://schemas.microsoft.com/office/drawing/2014/main" xmlns="" id="{5566C230-50A8-4591-A658-ACCC52D396D4}"/>
              </a:ext>
            </a:extLst>
          </p:cNvPr>
          <p:cNvSpPr/>
          <p:nvPr/>
        </p:nvSpPr>
        <p:spPr>
          <a:xfrm>
            <a:off x="106680" y="1083733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ángulo 7">
            <a:extLst>
              <a:ext uri="{FF2B5EF4-FFF2-40B4-BE49-F238E27FC236}">
                <a16:creationId xmlns:a16="http://schemas.microsoft.com/office/drawing/2014/main" xmlns="" id="{938705D0-F368-4A03-B072-9FB79FA2735C}"/>
              </a:ext>
            </a:extLst>
          </p:cNvPr>
          <p:cNvSpPr/>
          <p:nvPr/>
        </p:nvSpPr>
        <p:spPr>
          <a:xfrm>
            <a:off x="106680" y="2773475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ángulo 8">
            <a:extLst>
              <a:ext uri="{FF2B5EF4-FFF2-40B4-BE49-F238E27FC236}">
                <a16:creationId xmlns:a16="http://schemas.microsoft.com/office/drawing/2014/main" xmlns="" id="{C43C8C06-CED8-4B23-B1D5-09AFEC05FC52}"/>
              </a:ext>
            </a:extLst>
          </p:cNvPr>
          <p:cNvSpPr/>
          <p:nvPr/>
        </p:nvSpPr>
        <p:spPr>
          <a:xfrm>
            <a:off x="111434" y="4166109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9499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8AB8E4C8-2EC4-4B2D-A228-83C9FC359D04}"/>
              </a:ext>
            </a:extLst>
          </p:cNvPr>
          <p:cNvSpPr/>
          <p:nvPr/>
        </p:nvSpPr>
        <p:spPr>
          <a:xfrm>
            <a:off x="3810" y="1041729"/>
            <a:ext cx="1389380" cy="459356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720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deb2414_s0002g000453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88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2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7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06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4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4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32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33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IRChr04g015415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SC8Chr04g013840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QP8Chr04g01309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300Chr04g01182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61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8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6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5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1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6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8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3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38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3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39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06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6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600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36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31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39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7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5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5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6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1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7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9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deb2414_s0002g0004534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m_Chr07g00585851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m_Chr07g00585861-RLCK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F139CB1C-2193-4B52-B0B0-DAA645A63E6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75" t="4966" b="8287"/>
          <a:stretch/>
        </p:blipFill>
        <p:spPr>
          <a:xfrm>
            <a:off x="1325880" y="1082040"/>
            <a:ext cx="10866120" cy="4520776"/>
          </a:xfrm>
          <a:prstGeom prst="rect">
            <a:avLst/>
          </a:prstGeom>
        </p:spPr>
      </p:pic>
      <p:sp>
        <p:nvSpPr>
          <p:cNvPr id="5" name="Flecha: hacia abajo 4">
            <a:extLst>
              <a:ext uri="{FF2B5EF4-FFF2-40B4-BE49-F238E27FC236}">
                <a16:creationId xmlns:a16="http://schemas.microsoft.com/office/drawing/2014/main" xmlns="" id="{1E840B85-14D2-4B7B-91A4-55AA97B1A878}"/>
              </a:ext>
            </a:extLst>
          </p:cNvPr>
          <p:cNvSpPr/>
          <p:nvPr/>
        </p:nvSpPr>
        <p:spPr>
          <a:xfrm>
            <a:off x="4217842" y="846720"/>
            <a:ext cx="252000" cy="216000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Flecha: hacia abajo 5">
            <a:extLst>
              <a:ext uri="{FF2B5EF4-FFF2-40B4-BE49-F238E27FC236}">
                <a16:creationId xmlns:a16="http://schemas.microsoft.com/office/drawing/2014/main" xmlns="" id="{3F58AB04-294D-4561-B824-5877D54F9A38}"/>
              </a:ext>
            </a:extLst>
          </p:cNvPr>
          <p:cNvSpPr/>
          <p:nvPr/>
        </p:nvSpPr>
        <p:spPr>
          <a:xfrm>
            <a:off x="5936582" y="846720"/>
            <a:ext cx="252000" cy="216000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ángulo 6">
            <a:extLst>
              <a:ext uri="{FF2B5EF4-FFF2-40B4-BE49-F238E27FC236}">
                <a16:creationId xmlns:a16="http://schemas.microsoft.com/office/drawing/2014/main" xmlns="" id="{36BD2B10-0E2D-494D-A9BC-335E5EA53FC5}"/>
              </a:ext>
            </a:extLst>
          </p:cNvPr>
          <p:cNvSpPr/>
          <p:nvPr/>
        </p:nvSpPr>
        <p:spPr>
          <a:xfrm>
            <a:off x="106680" y="1083733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ángulo 7">
            <a:extLst>
              <a:ext uri="{FF2B5EF4-FFF2-40B4-BE49-F238E27FC236}">
                <a16:creationId xmlns:a16="http://schemas.microsoft.com/office/drawing/2014/main" xmlns="" id="{3E7493C8-D1FB-4454-A767-F25D60AFAA36}"/>
              </a:ext>
            </a:extLst>
          </p:cNvPr>
          <p:cNvSpPr/>
          <p:nvPr/>
        </p:nvSpPr>
        <p:spPr>
          <a:xfrm>
            <a:off x="106680" y="2773475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ángulo 8">
            <a:extLst>
              <a:ext uri="{FF2B5EF4-FFF2-40B4-BE49-F238E27FC236}">
                <a16:creationId xmlns:a16="http://schemas.microsoft.com/office/drawing/2014/main" xmlns="" id="{69D16325-25B8-42D6-9D09-75D1D0171644}"/>
              </a:ext>
            </a:extLst>
          </p:cNvPr>
          <p:cNvSpPr/>
          <p:nvPr/>
        </p:nvSpPr>
        <p:spPr>
          <a:xfrm>
            <a:off x="111434" y="4166109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4574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B8CC5016-F151-49F7-8F91-992C7DFDAC08}"/>
              </a:ext>
            </a:extLst>
          </p:cNvPr>
          <p:cNvSpPr/>
          <p:nvPr/>
        </p:nvSpPr>
        <p:spPr>
          <a:xfrm>
            <a:off x="3810" y="1041729"/>
            <a:ext cx="1389380" cy="459356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720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deb2414_s0002g000453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88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2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7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06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4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4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32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33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IRChr04g015415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SC8Chr04g013840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QP8Chr04g01309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300Chr04g01182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610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8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6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5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11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7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6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8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3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38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33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392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PI659440Chr04g0140691-CrRL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66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nDeb2Chr04g005600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36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31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39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XRQChr04g014247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HA89Chr04g013055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LR1Chr04g01225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06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RHA438Chr04g015410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7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B117Chr04_003659-RLC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deb2414_s0002g00045341-RLCK 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m_Chr07g00585851-CrRLK</a:t>
            </a:r>
          </a:p>
          <a:p>
            <a:pPr algn="r"/>
            <a:r>
              <a:rPr lang="en-GB" sz="650" dirty="0">
                <a:latin typeface="+mj-lt"/>
                <a:cs typeface="Arial" panose="020B0604020202020204" pitchFamily="34" charset="0"/>
              </a:rPr>
              <a:t>Hanom_Chr07g00585861-RLCK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C73F0D4D-8EEE-48DF-82B0-6122A18F74A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50" t="5259" b="8288"/>
          <a:stretch/>
        </p:blipFill>
        <p:spPr>
          <a:xfrm>
            <a:off x="1310640" y="1097280"/>
            <a:ext cx="10881360" cy="4505536"/>
          </a:xfrm>
          <a:prstGeom prst="rect">
            <a:avLst/>
          </a:prstGeom>
        </p:spPr>
      </p:pic>
      <p:sp>
        <p:nvSpPr>
          <p:cNvPr id="5" name="Flecha: hacia abajo 4">
            <a:extLst>
              <a:ext uri="{FF2B5EF4-FFF2-40B4-BE49-F238E27FC236}">
                <a16:creationId xmlns:a16="http://schemas.microsoft.com/office/drawing/2014/main" xmlns="" id="{46ABC518-9C09-44F6-AC6F-A989B649304B}"/>
              </a:ext>
            </a:extLst>
          </p:cNvPr>
          <p:cNvSpPr/>
          <p:nvPr/>
        </p:nvSpPr>
        <p:spPr>
          <a:xfrm>
            <a:off x="10285925" y="881280"/>
            <a:ext cx="252000" cy="216000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ángulo 6">
            <a:extLst>
              <a:ext uri="{FF2B5EF4-FFF2-40B4-BE49-F238E27FC236}">
                <a16:creationId xmlns:a16="http://schemas.microsoft.com/office/drawing/2014/main" xmlns="" id="{653CB284-2A8D-410D-B2EF-834CDCC2BFCA}"/>
              </a:ext>
            </a:extLst>
          </p:cNvPr>
          <p:cNvSpPr/>
          <p:nvPr/>
        </p:nvSpPr>
        <p:spPr>
          <a:xfrm>
            <a:off x="106680" y="1083733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ángulo 7">
            <a:extLst>
              <a:ext uri="{FF2B5EF4-FFF2-40B4-BE49-F238E27FC236}">
                <a16:creationId xmlns:a16="http://schemas.microsoft.com/office/drawing/2014/main" xmlns="" id="{15B892CC-84C8-4020-9E51-2A965FF855FC}"/>
              </a:ext>
            </a:extLst>
          </p:cNvPr>
          <p:cNvSpPr/>
          <p:nvPr/>
        </p:nvSpPr>
        <p:spPr>
          <a:xfrm>
            <a:off x="106680" y="2773475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ángulo 8">
            <a:extLst>
              <a:ext uri="{FF2B5EF4-FFF2-40B4-BE49-F238E27FC236}">
                <a16:creationId xmlns:a16="http://schemas.microsoft.com/office/drawing/2014/main" xmlns="" id="{DCE35D83-F596-4FD9-AF8E-5842BAB64995}"/>
              </a:ext>
            </a:extLst>
          </p:cNvPr>
          <p:cNvSpPr/>
          <p:nvPr/>
        </p:nvSpPr>
        <p:spPr>
          <a:xfrm>
            <a:off x="111434" y="4166109"/>
            <a:ext cx="1244600" cy="10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3899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222</Words>
  <Application>Microsoft Office PowerPoint</Application>
  <PresentationFormat>Personalizado</PresentationFormat>
  <Paragraphs>181</Paragraphs>
  <Slides>4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5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len Fernandez</dc:creator>
  <cp:lastModifiedBy>Bego</cp:lastModifiedBy>
  <cp:revision>10</cp:revision>
  <dcterms:created xsi:type="dcterms:W3CDTF">2025-09-29T16:04:58Z</dcterms:created>
  <dcterms:modified xsi:type="dcterms:W3CDTF">2026-02-11T12:03:08Z</dcterms:modified>
</cp:coreProperties>
</file>